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5762CD-2D4C-413F-9CBD-C989A38C712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3FC009-975D-40C2-916B-E69D2E6EBDC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7FF417-69D2-4C91-AE44-D2967F541B9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909C07-F98D-4FDF-8D10-B0C3BB5350F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572E62-7F66-43C2-BCAC-B7F5DC4E704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7D43A0-5F52-47BD-BC86-1BF91F7E37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476E6B-C251-41F0-86B5-8BB41FF0673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53D5BB-7491-4753-8BC2-5A0131798A6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8C0237-0F67-4FF1-9B91-FDE366098E8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08E0BA-3C86-40C7-81EC-0E281E5BEE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6BD829-B5C6-4E51-8AC3-084D4E4340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1F2862-50E5-400B-930A-5F18F67D23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36E6BD6-7F6E-44F8-B82F-94C7996471C8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765000" y="1042920"/>
          <a:ext cx="5181840" cy="74448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65000" y="1042920"/>
                    <a:ext cx="5181840" cy="744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"/>
          <p:cNvSpPr/>
          <p:nvPr/>
        </p:nvSpPr>
        <p:spPr>
          <a:xfrm>
            <a:off x="476280" y="179280"/>
            <a:ext cx="6048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Arial"/>
              </a:rPr>
              <a:t>Table S2:</a:t>
            </a: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 Homologies between human and murine autoantigens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44" name=""/>
          <p:cNvGraphicFramePr/>
          <p:nvPr/>
        </p:nvGraphicFramePr>
        <p:xfrm>
          <a:off x="685800" y="2124000"/>
          <a:ext cx="5467320" cy="501984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45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685800" y="2124000"/>
                    <a:ext cx="5467320" cy="5019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6" name=""/>
          <p:cNvSpPr/>
          <p:nvPr/>
        </p:nvSpPr>
        <p:spPr>
          <a:xfrm>
            <a:off x="190440" y="97164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182520" y="205092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189000" y="7524720"/>
            <a:ext cx="6335640" cy="110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57200" indent="-457200" algn="just">
              <a:lnSpc>
                <a:spcPct val="100000"/>
              </a:lnSpc>
              <a:spcBef>
                <a:spcPts val="751"/>
              </a:spcBef>
              <a:buClr>
                <a:srgbClr val="000000"/>
              </a:buClr>
              <a:buFont typeface="Arial"/>
              <a:buAutoNum type="alphaU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Accession codes from National Center for Biotechnology Information (NCBI) and percentages of homology between the human and murine whole proteins sequence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 algn="just">
              <a:lnSpc>
                <a:spcPct val="100000"/>
              </a:lnSpc>
              <a:spcBef>
                <a:spcPts val="751"/>
              </a:spcBef>
              <a:buClr>
                <a:srgbClr val="000000"/>
              </a:buClr>
              <a:buFont typeface="Arial"/>
              <a:buAutoNum type="alphaU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Sequence homologies between human and murine autoantigens were analyzed by the basic logical alignment search tool using NCBI network service. I: identical amino acids; *: conservative substitutions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03T10:52:11Z</dcterms:created>
  <dc:creator> </dc:creator>
  <dc:description/>
  <dc:language>en-US</dc:language>
  <cp:lastModifiedBy>dimes</cp:lastModifiedBy>
  <dcterms:modified xsi:type="dcterms:W3CDTF">2013-02-05T09:03:46Z</dcterms:modified>
  <cp:revision>36</cp:revision>
  <dc:subject/>
  <dc:title>Presentazione di PowerPoint</dc:title>
</cp:coreProperties>
</file>